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60" y="3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87044-61AA-45B9-ADC1-F5B685167FD4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8709B-C85F-4E59-B596-D19073F503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56233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87044-61AA-45B9-ADC1-F5B685167FD4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8709B-C85F-4E59-B596-D19073F503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38530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87044-61AA-45B9-ADC1-F5B685167FD4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8709B-C85F-4E59-B596-D19073F503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32826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87044-61AA-45B9-ADC1-F5B685167FD4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8709B-C85F-4E59-B596-D19073F503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70909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87044-61AA-45B9-ADC1-F5B685167FD4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8709B-C85F-4E59-B596-D19073F503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870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87044-61AA-45B9-ADC1-F5B685167FD4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8709B-C85F-4E59-B596-D19073F503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55075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87044-61AA-45B9-ADC1-F5B685167FD4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8709B-C85F-4E59-B596-D19073F503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20122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87044-61AA-45B9-ADC1-F5B685167FD4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8709B-C85F-4E59-B596-D19073F503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5471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87044-61AA-45B9-ADC1-F5B685167FD4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8709B-C85F-4E59-B596-D19073F503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00869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87044-61AA-45B9-ADC1-F5B685167FD4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8709B-C85F-4E59-B596-D19073F503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39209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87044-61AA-45B9-ADC1-F5B685167FD4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8709B-C85F-4E59-B596-D19073F503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13018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687044-61AA-45B9-ADC1-F5B685167FD4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D8709B-C85F-4E59-B596-D19073F503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58166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zh-CN" dirty="0" smtClean="0"/>
              <a:t>Figure 7E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7767576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>
            <a:extLst>
              <a:ext uri="{FF2B5EF4-FFF2-40B4-BE49-F238E27FC236}">
                <a16:creationId xmlns:a16="http://schemas.microsoft.com/office/drawing/2014/main" id="{15AFCC22-D5B1-4743-8AB6-0C18F2917837}"/>
              </a:ext>
            </a:extLst>
          </p:cNvPr>
          <p:cNvSpPr txBox="1"/>
          <p:nvPr/>
        </p:nvSpPr>
        <p:spPr>
          <a:xfrm>
            <a:off x="1703749" y="1919846"/>
            <a:ext cx="5095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03D0D4D2-D593-4C42-BC80-80309827D836}"/>
              </a:ext>
            </a:extLst>
          </p:cNvPr>
          <p:cNvSpPr txBox="1"/>
          <p:nvPr/>
        </p:nvSpPr>
        <p:spPr>
          <a:xfrm>
            <a:off x="1961515" y="1838475"/>
            <a:ext cx="2088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2400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 </a:t>
            </a:r>
            <a:r>
              <a:rPr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+</a:t>
            </a:r>
            <a:r>
              <a:rPr lang="zh-CN" altLang="en-US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   －    －    －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CCFFB12-128E-44A4-8A1D-C18EAAFF953B}"/>
              </a:ext>
            </a:extLst>
          </p:cNvPr>
          <p:cNvSpPr txBox="1"/>
          <p:nvPr/>
        </p:nvSpPr>
        <p:spPr>
          <a:xfrm>
            <a:off x="1506181" y="2218960"/>
            <a:ext cx="8140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HRAT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7674E3DF-06B5-4E47-847A-06B3C3612C27}"/>
              </a:ext>
            </a:extLst>
          </p:cNvPr>
          <p:cNvSpPr txBox="1"/>
          <p:nvPr/>
        </p:nvSpPr>
        <p:spPr>
          <a:xfrm>
            <a:off x="2091279" y="2193358"/>
            <a:ext cx="195814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－    </a:t>
            </a:r>
            <a:r>
              <a:rPr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+     +</a:t>
            </a:r>
            <a:r>
              <a:rPr lang="zh-CN" altLang="en-US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     </a:t>
            </a:r>
            <a:r>
              <a:rPr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+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3434891A-D75F-4703-8D4E-B576D9712953}"/>
              </a:ext>
            </a:extLst>
          </p:cNvPr>
          <p:cNvSpPr txBox="1"/>
          <p:nvPr/>
        </p:nvSpPr>
        <p:spPr>
          <a:xfrm>
            <a:off x="1193200" y="2494328"/>
            <a:ext cx="11440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NC mimic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9D648D2C-4739-4C66-A3CB-62BA63E7E899}"/>
              </a:ext>
            </a:extLst>
          </p:cNvPr>
          <p:cNvSpPr txBox="1"/>
          <p:nvPr/>
        </p:nvSpPr>
        <p:spPr>
          <a:xfrm>
            <a:off x="1043047" y="2794320"/>
            <a:ext cx="12224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iR-370-3p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7585BBAD-A65D-4A11-85EA-AF72D513B59F}"/>
              </a:ext>
            </a:extLst>
          </p:cNvPr>
          <p:cNvSpPr txBox="1"/>
          <p:nvPr/>
        </p:nvSpPr>
        <p:spPr>
          <a:xfrm>
            <a:off x="2091279" y="2788155"/>
            <a:ext cx="195814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－   －</a:t>
            </a:r>
            <a:r>
              <a:rPr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   </a:t>
            </a:r>
            <a:r>
              <a:rPr lang="zh-CN" altLang="en-US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－     </a:t>
            </a:r>
            <a:r>
              <a:rPr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+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0D1168E6-44E0-4484-A342-805868B2E448}"/>
              </a:ext>
            </a:extLst>
          </p:cNvPr>
          <p:cNvSpPr txBox="1"/>
          <p:nvPr/>
        </p:nvSpPr>
        <p:spPr>
          <a:xfrm>
            <a:off x="2115343" y="2497299"/>
            <a:ext cx="195814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－   －</a:t>
            </a:r>
            <a:r>
              <a:rPr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   +</a:t>
            </a:r>
            <a:r>
              <a:rPr lang="zh-CN" altLang="en-US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    －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3D69776C-B11A-4E7D-81B8-098A1EA9799F}"/>
              </a:ext>
            </a:extLst>
          </p:cNvPr>
          <p:cNvSpPr txBox="1"/>
          <p:nvPr/>
        </p:nvSpPr>
        <p:spPr>
          <a:xfrm>
            <a:off x="577488" y="956837"/>
            <a:ext cx="762227" cy="3069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RNF4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AD975A40-3983-4430-BD53-FA584D16A1A9}"/>
              </a:ext>
            </a:extLst>
          </p:cNvPr>
          <p:cNvSpPr txBox="1"/>
          <p:nvPr/>
        </p:nvSpPr>
        <p:spPr>
          <a:xfrm>
            <a:off x="1152583" y="1509070"/>
            <a:ext cx="9386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4139733" y="1009539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34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4139733" y="704939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2488154" y="260815"/>
            <a:ext cx="1212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</a:rPr>
              <a:t>Repeat 1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4139733" y="1492995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图片 26"/>
          <p:cNvPicPr preferRelativeResize="0"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5571" y="712220"/>
            <a:ext cx="2886906" cy="684000"/>
          </a:xfrm>
          <a:prstGeom prst="rect">
            <a:avLst/>
          </a:prstGeom>
        </p:spPr>
      </p:pic>
      <p:pic>
        <p:nvPicPr>
          <p:cNvPr id="28" name="图片 27"/>
          <p:cNvPicPr preferRelativeResize="0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62477" y="1423821"/>
            <a:ext cx="2340000" cy="540000"/>
          </a:xfrm>
          <a:prstGeom prst="rect">
            <a:avLst/>
          </a:prstGeom>
        </p:spPr>
      </p:pic>
      <p:sp>
        <p:nvSpPr>
          <p:cNvPr id="29" name="文本框 28">
            <a:extLst>
              <a:ext uri="{FF2B5EF4-FFF2-40B4-BE49-F238E27FC236}">
                <a16:creationId xmlns:a16="http://schemas.microsoft.com/office/drawing/2014/main" id="{15AFCC22-D5B1-4743-8AB6-0C18F2917837}"/>
              </a:ext>
            </a:extLst>
          </p:cNvPr>
          <p:cNvSpPr txBox="1"/>
          <p:nvPr/>
        </p:nvSpPr>
        <p:spPr>
          <a:xfrm>
            <a:off x="6589942" y="1892754"/>
            <a:ext cx="5095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03D0D4D2-D593-4C42-BC80-80309827D836}"/>
              </a:ext>
            </a:extLst>
          </p:cNvPr>
          <p:cNvSpPr txBox="1"/>
          <p:nvPr/>
        </p:nvSpPr>
        <p:spPr>
          <a:xfrm>
            <a:off x="6847708" y="1811383"/>
            <a:ext cx="2088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2400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 </a:t>
            </a:r>
            <a:r>
              <a:rPr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+</a:t>
            </a:r>
            <a:r>
              <a:rPr lang="zh-CN" altLang="en-US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   －    －    －</a:t>
            </a: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0CCFFB12-128E-44A4-8A1D-C18EAAFF953B}"/>
              </a:ext>
            </a:extLst>
          </p:cNvPr>
          <p:cNvSpPr txBox="1"/>
          <p:nvPr/>
        </p:nvSpPr>
        <p:spPr>
          <a:xfrm>
            <a:off x="6392374" y="2191868"/>
            <a:ext cx="8140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HRAT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7674E3DF-06B5-4E47-847A-06B3C3612C27}"/>
              </a:ext>
            </a:extLst>
          </p:cNvPr>
          <p:cNvSpPr txBox="1"/>
          <p:nvPr/>
        </p:nvSpPr>
        <p:spPr>
          <a:xfrm>
            <a:off x="6977472" y="2166266"/>
            <a:ext cx="195814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－    </a:t>
            </a:r>
            <a:r>
              <a:rPr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+     +</a:t>
            </a:r>
            <a:r>
              <a:rPr lang="zh-CN" altLang="en-US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     </a:t>
            </a:r>
            <a:r>
              <a:rPr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+</a:t>
            </a:r>
            <a:endParaRPr lang="zh-CN" altLang="en-US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3434891A-D75F-4703-8D4E-B576D9712953}"/>
              </a:ext>
            </a:extLst>
          </p:cNvPr>
          <p:cNvSpPr txBox="1"/>
          <p:nvPr/>
        </p:nvSpPr>
        <p:spPr>
          <a:xfrm>
            <a:off x="6079393" y="2467236"/>
            <a:ext cx="11440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NC mimic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9D648D2C-4739-4C66-A3CB-62BA63E7E899}"/>
              </a:ext>
            </a:extLst>
          </p:cNvPr>
          <p:cNvSpPr txBox="1"/>
          <p:nvPr/>
        </p:nvSpPr>
        <p:spPr>
          <a:xfrm>
            <a:off x="5929240" y="2767228"/>
            <a:ext cx="12224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iR-370-3p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7585BBAD-A65D-4A11-85EA-AF72D513B59F}"/>
              </a:ext>
            </a:extLst>
          </p:cNvPr>
          <p:cNvSpPr txBox="1"/>
          <p:nvPr/>
        </p:nvSpPr>
        <p:spPr>
          <a:xfrm>
            <a:off x="6977472" y="2761063"/>
            <a:ext cx="195814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－   －</a:t>
            </a:r>
            <a:r>
              <a:rPr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   </a:t>
            </a:r>
            <a:r>
              <a:rPr lang="zh-CN" altLang="en-US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－     </a:t>
            </a:r>
            <a:r>
              <a:rPr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+</a:t>
            </a:r>
            <a:endParaRPr lang="zh-CN" altLang="en-US" dirty="0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0D1168E6-44E0-4484-A342-805868B2E448}"/>
              </a:ext>
            </a:extLst>
          </p:cNvPr>
          <p:cNvSpPr txBox="1"/>
          <p:nvPr/>
        </p:nvSpPr>
        <p:spPr>
          <a:xfrm>
            <a:off x="7001536" y="2470207"/>
            <a:ext cx="195814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－   －</a:t>
            </a:r>
            <a:r>
              <a:rPr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   +</a:t>
            </a:r>
            <a:r>
              <a:rPr lang="zh-CN" altLang="en-US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    －</a:t>
            </a:r>
            <a:endParaRPr lang="zh-CN" altLang="en-US" dirty="0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3D69776C-B11A-4E7D-81B8-098A1EA9799F}"/>
              </a:ext>
            </a:extLst>
          </p:cNvPr>
          <p:cNvSpPr txBox="1"/>
          <p:nvPr/>
        </p:nvSpPr>
        <p:spPr>
          <a:xfrm>
            <a:off x="5548126" y="825571"/>
            <a:ext cx="762227" cy="3069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RNF4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AD975A40-3983-4430-BD53-FA584D16A1A9}"/>
              </a:ext>
            </a:extLst>
          </p:cNvPr>
          <p:cNvSpPr txBox="1"/>
          <p:nvPr/>
        </p:nvSpPr>
        <p:spPr>
          <a:xfrm>
            <a:off x="5987048" y="1461609"/>
            <a:ext cx="9386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8935612" y="982640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34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8935612" y="617080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7374347" y="233723"/>
            <a:ext cx="1212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</a:rPr>
              <a:t>Repeat </a:t>
            </a:r>
            <a:r>
              <a:rPr lang="en-US" altLang="zh-CN" dirty="0" smtClean="0">
                <a:solidFill>
                  <a:srgbClr val="FF0000"/>
                </a:solidFill>
              </a:rPr>
              <a:t>2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9044406" y="1402575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图片 44"/>
          <p:cNvPicPr preferRelativeResize="0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7610" y="637025"/>
            <a:ext cx="2700000" cy="684000"/>
          </a:xfrm>
          <a:prstGeom prst="rect">
            <a:avLst/>
          </a:prstGeom>
        </p:spPr>
      </p:pic>
      <p:pic>
        <p:nvPicPr>
          <p:cNvPr id="46" name="图片 45"/>
          <p:cNvPicPr preferRelativeResize="0"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06241" y="1347016"/>
            <a:ext cx="2412000" cy="540000"/>
          </a:xfrm>
          <a:prstGeom prst="rect">
            <a:avLst/>
          </a:prstGeom>
        </p:spPr>
      </p:pic>
      <p:sp>
        <p:nvSpPr>
          <p:cNvPr id="47" name="文本框 46">
            <a:extLst>
              <a:ext uri="{FF2B5EF4-FFF2-40B4-BE49-F238E27FC236}">
                <a16:creationId xmlns:a16="http://schemas.microsoft.com/office/drawing/2014/main" id="{15AFCC22-D5B1-4743-8AB6-0C18F2917837}"/>
              </a:ext>
            </a:extLst>
          </p:cNvPr>
          <p:cNvSpPr txBox="1"/>
          <p:nvPr/>
        </p:nvSpPr>
        <p:spPr>
          <a:xfrm>
            <a:off x="1685269" y="5065443"/>
            <a:ext cx="5095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03D0D4D2-D593-4C42-BC80-80309827D836}"/>
              </a:ext>
            </a:extLst>
          </p:cNvPr>
          <p:cNvSpPr txBox="1"/>
          <p:nvPr/>
        </p:nvSpPr>
        <p:spPr>
          <a:xfrm>
            <a:off x="1943035" y="4984072"/>
            <a:ext cx="2088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2400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 </a:t>
            </a:r>
            <a:r>
              <a:rPr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+</a:t>
            </a:r>
            <a:r>
              <a:rPr lang="zh-CN" altLang="en-US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   －    －    －</a:t>
            </a: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0CCFFB12-128E-44A4-8A1D-C18EAAFF953B}"/>
              </a:ext>
            </a:extLst>
          </p:cNvPr>
          <p:cNvSpPr txBox="1"/>
          <p:nvPr/>
        </p:nvSpPr>
        <p:spPr>
          <a:xfrm>
            <a:off x="1487701" y="5364557"/>
            <a:ext cx="8140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HRAT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7674E3DF-06B5-4E47-847A-06B3C3612C27}"/>
              </a:ext>
            </a:extLst>
          </p:cNvPr>
          <p:cNvSpPr txBox="1"/>
          <p:nvPr/>
        </p:nvSpPr>
        <p:spPr>
          <a:xfrm>
            <a:off x="2072799" y="5338955"/>
            <a:ext cx="195814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－    </a:t>
            </a:r>
            <a:r>
              <a:rPr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+     +</a:t>
            </a:r>
            <a:r>
              <a:rPr lang="zh-CN" altLang="en-US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     </a:t>
            </a:r>
            <a:r>
              <a:rPr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+</a:t>
            </a:r>
            <a:endParaRPr lang="zh-CN" altLang="en-US" dirty="0"/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3434891A-D75F-4703-8D4E-B576D9712953}"/>
              </a:ext>
            </a:extLst>
          </p:cNvPr>
          <p:cNvSpPr txBox="1"/>
          <p:nvPr/>
        </p:nvSpPr>
        <p:spPr>
          <a:xfrm>
            <a:off x="1174720" y="5639925"/>
            <a:ext cx="11440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NC mimic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9D648D2C-4739-4C66-A3CB-62BA63E7E899}"/>
              </a:ext>
            </a:extLst>
          </p:cNvPr>
          <p:cNvSpPr txBox="1"/>
          <p:nvPr/>
        </p:nvSpPr>
        <p:spPr>
          <a:xfrm>
            <a:off x="1024567" y="5939917"/>
            <a:ext cx="12224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iR-370-3p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7585BBAD-A65D-4A11-85EA-AF72D513B59F}"/>
              </a:ext>
            </a:extLst>
          </p:cNvPr>
          <p:cNvSpPr txBox="1"/>
          <p:nvPr/>
        </p:nvSpPr>
        <p:spPr>
          <a:xfrm>
            <a:off x="2072799" y="5933752"/>
            <a:ext cx="195814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－   －</a:t>
            </a:r>
            <a:r>
              <a:rPr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   </a:t>
            </a:r>
            <a:r>
              <a:rPr lang="zh-CN" altLang="en-US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－     </a:t>
            </a:r>
            <a:r>
              <a:rPr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+</a:t>
            </a:r>
            <a:endParaRPr lang="zh-CN" altLang="en-US" dirty="0"/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0D1168E6-44E0-4484-A342-805868B2E448}"/>
              </a:ext>
            </a:extLst>
          </p:cNvPr>
          <p:cNvSpPr txBox="1"/>
          <p:nvPr/>
        </p:nvSpPr>
        <p:spPr>
          <a:xfrm>
            <a:off x="2096863" y="5642896"/>
            <a:ext cx="195814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－   －</a:t>
            </a:r>
            <a:r>
              <a:rPr lang="en-US" altLang="zh-CN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   +</a:t>
            </a:r>
            <a:r>
              <a:rPr lang="zh-CN" altLang="en-US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    －</a:t>
            </a:r>
            <a:endParaRPr lang="zh-CN" altLang="en-US" dirty="0"/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3D69776C-B11A-4E7D-81B8-098A1EA9799F}"/>
              </a:ext>
            </a:extLst>
          </p:cNvPr>
          <p:cNvSpPr txBox="1"/>
          <p:nvPr/>
        </p:nvSpPr>
        <p:spPr>
          <a:xfrm>
            <a:off x="1043047" y="3904698"/>
            <a:ext cx="762227" cy="3069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RNF4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AD975A40-3983-4430-BD53-FA584D16A1A9}"/>
              </a:ext>
            </a:extLst>
          </p:cNvPr>
          <p:cNvSpPr txBox="1"/>
          <p:nvPr/>
        </p:nvSpPr>
        <p:spPr>
          <a:xfrm>
            <a:off x="1043047" y="4549913"/>
            <a:ext cx="9386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4084262" y="4108280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34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4084262" y="3782772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/>
          <p:cNvSpPr txBox="1"/>
          <p:nvPr/>
        </p:nvSpPr>
        <p:spPr>
          <a:xfrm>
            <a:off x="2469674" y="3406412"/>
            <a:ext cx="1212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</a:rPr>
              <a:t>Repeat </a:t>
            </a:r>
            <a:r>
              <a:rPr lang="en-US" altLang="zh-CN" dirty="0" smtClean="0">
                <a:solidFill>
                  <a:srgbClr val="FF0000"/>
                </a:solidFill>
              </a:rPr>
              <a:t>3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4083643" y="4546620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3" name="图片 62"/>
          <p:cNvPicPr preferRelativeResize="0"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6762" y="3782772"/>
            <a:ext cx="2412000" cy="648000"/>
          </a:xfrm>
          <a:prstGeom prst="rect">
            <a:avLst/>
          </a:prstGeom>
        </p:spPr>
      </p:pic>
      <p:pic>
        <p:nvPicPr>
          <p:cNvPr id="64" name="图片 63"/>
          <p:cNvPicPr preferRelativeResize="0">
            <a:picLocks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6762" y="4462154"/>
            <a:ext cx="2412000" cy="57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147542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98</Words>
  <Application>Microsoft Office PowerPoint</Application>
  <PresentationFormat>宽屏</PresentationFormat>
  <Paragraphs>43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宋体</vt:lpstr>
      <vt:lpstr>Arial</vt:lpstr>
      <vt:lpstr>Office 主题​​</vt:lpstr>
      <vt:lpstr>Figure 7E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7E</dc:title>
  <dc:creator>Z</dc:creator>
  <cp:lastModifiedBy>Z</cp:lastModifiedBy>
  <cp:revision>3</cp:revision>
  <dcterms:created xsi:type="dcterms:W3CDTF">2022-06-01T01:53:28Z</dcterms:created>
  <dcterms:modified xsi:type="dcterms:W3CDTF">2022-06-01T02:16:16Z</dcterms:modified>
</cp:coreProperties>
</file>